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3" d="100"/>
          <a:sy n="63" d="100"/>
        </p:scale>
        <p:origin x="56" y="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3CCB2A-FBCB-4946-9FD9-8A14335E52C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BDFB92A-EB56-4F33-8BD1-56EE11F92CC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8989A86-E7CA-46FB-A637-60255EF4D5DB}"/>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827C193D-7C57-443A-9856-310CF298D9F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DAE1148-23E3-457A-998F-1AFA4EBF9B68}"/>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33402663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F5B248-80FC-45B9-BC4E-91119FF0604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68EEBC0-1643-4DB5-9459-2F0F4AEDFCF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6A4720-FAFC-4BA5-8C24-6CE61CE39848}"/>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9AE5843C-B07C-40B1-98C2-D04C683F2AC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ADE8508-9E28-462D-A282-35CEC50955A3}"/>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6971684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20B5B10-E61D-49B6-BB93-97294A6A59E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84304DD-7AA5-476B-9A58-76A3A612F52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816D416-16D9-4173-852B-94C8A514BC25}"/>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7A82B6F9-2D7E-43DE-BEC3-2B4106434BF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23CAB01-8419-492B-9CF6-ADE972128D2F}"/>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4266682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94FFB6-B4DE-4B31-8ED6-A2CEA52BE16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D382AC0-6C37-4B1B-82D6-B02DEC83017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E01B17-B1F1-4A24-B017-DA1EC1333EBC}"/>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EE1059D6-FB97-4821-A537-ED77A26212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676165E-3683-4156-805D-606D38D929EA}"/>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31736411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CF1CEA-CEBB-4EAD-A4B4-EF1506950E1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72B482C-502D-4988-B10D-F5A50A781E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2D19CE5A-4799-4604-B586-6759FAFA5CE8}"/>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F0C1BEBF-919C-4CAC-A7F5-20AD4B620DF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7782AD7-CA2A-4667-BEA2-B5831B17CE7D}"/>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40499357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772849-7355-4696-B5D3-4F21B30D352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A7EA8BA-215B-4123-89EB-9DF5FE823079}"/>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12EF922-2A09-429D-9CD4-9D53C9018BBA}"/>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3C689B1-3BB0-4EB3-9FB1-34C4A0A67FA0}"/>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6" name="Footer Placeholder 5">
            <a:extLst>
              <a:ext uri="{FF2B5EF4-FFF2-40B4-BE49-F238E27FC236}">
                <a16:creationId xmlns:a16="http://schemas.microsoft.com/office/drawing/2014/main" id="{C56FD728-624E-490E-96A8-AB2CC02221E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5A13E38-75A2-45A1-9A5F-5608035CA9FD}"/>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2640704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CF8101-F6FF-40FA-8331-8D2A7BF6C2D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C5CDE7D-433A-44FB-A8E8-413A1258B3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A0043196-1800-4366-B666-D1F1B1CB6785}"/>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0A1B97D-B32B-4A50-A071-2323B68CABE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F3F38B21-2280-41B8-A5CC-45A8A80EC99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498C04D-A723-4B59-90D9-E7E55984F25D}"/>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8" name="Footer Placeholder 7">
            <a:extLst>
              <a:ext uri="{FF2B5EF4-FFF2-40B4-BE49-F238E27FC236}">
                <a16:creationId xmlns:a16="http://schemas.microsoft.com/office/drawing/2014/main" id="{4163942A-CC4E-46D1-A5BE-A4E0866D1948}"/>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B7136E92-7377-4EE5-BEC3-E6AC2D523EB0}"/>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24026098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1A7039-8C74-46D1-998F-DAEFE302463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ABCA5B5-A087-4873-BF99-88741B19ED94}"/>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4" name="Footer Placeholder 3">
            <a:extLst>
              <a:ext uri="{FF2B5EF4-FFF2-40B4-BE49-F238E27FC236}">
                <a16:creationId xmlns:a16="http://schemas.microsoft.com/office/drawing/2014/main" id="{DF794D4F-95DE-42C7-A4BC-1DBFE53AB484}"/>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5B9B7E08-347C-4C69-ABC2-4DDB6FEBF1D6}"/>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31159899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809ABFD-270A-463B-A059-304624A490E7}"/>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3" name="Footer Placeholder 2">
            <a:extLst>
              <a:ext uri="{FF2B5EF4-FFF2-40B4-BE49-F238E27FC236}">
                <a16:creationId xmlns:a16="http://schemas.microsoft.com/office/drawing/2014/main" id="{AEDA34D8-C340-49A7-AB17-46A96DBE2B02}"/>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7877E28E-5272-4925-99E5-B147554DB234}"/>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804032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AD99F9-5B17-4930-8ED6-08ADD3FC33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05D1AF2-D576-4647-B8AC-1AE8BCD1586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DDF18E3-D451-47FC-9DA0-B105D29DDE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42077F2-29A8-4848-9AF3-5CE278F7A132}"/>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6" name="Footer Placeholder 5">
            <a:extLst>
              <a:ext uri="{FF2B5EF4-FFF2-40B4-BE49-F238E27FC236}">
                <a16:creationId xmlns:a16="http://schemas.microsoft.com/office/drawing/2014/main" id="{0D509B99-9C4D-4C34-93DC-A0E675D9816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EA926A2-F96E-4BEF-B8A0-DB4B7E365814}"/>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2630548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58EC87-C9BE-4CAE-918E-303916D631A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FBDE1C9-048A-4C8F-A606-FB501F8BE91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4734E8CE-8265-4CD3-80AA-7FF7996344B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DD6267A-5AD3-4854-B82D-E56F323C089C}"/>
              </a:ext>
            </a:extLst>
          </p:cNvPr>
          <p:cNvSpPr>
            <a:spLocks noGrp="1"/>
          </p:cNvSpPr>
          <p:nvPr>
            <p:ph type="dt" sz="half" idx="10"/>
          </p:nvPr>
        </p:nvSpPr>
        <p:spPr/>
        <p:txBody>
          <a:bodyPr/>
          <a:lstStyle/>
          <a:p>
            <a:fld id="{0D64E918-A57F-47C1-81BD-0D0489642ADB}" type="datetimeFigureOut">
              <a:rPr lang="en-US" smtClean="0"/>
              <a:t>4/23/2024</a:t>
            </a:fld>
            <a:endParaRPr lang="en-US" dirty="0"/>
          </a:p>
        </p:txBody>
      </p:sp>
      <p:sp>
        <p:nvSpPr>
          <p:cNvPr id="6" name="Footer Placeholder 5">
            <a:extLst>
              <a:ext uri="{FF2B5EF4-FFF2-40B4-BE49-F238E27FC236}">
                <a16:creationId xmlns:a16="http://schemas.microsoft.com/office/drawing/2014/main" id="{CB4C1549-1F52-4273-A755-1F9E2B8392B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0070BF5-3049-46B3-89FD-514BA6AE9481}"/>
              </a:ext>
            </a:extLst>
          </p:cNvPr>
          <p:cNvSpPr>
            <a:spLocks noGrp="1"/>
          </p:cNvSpPr>
          <p:nvPr>
            <p:ph type="sldNum" sz="quarter" idx="12"/>
          </p:nvPr>
        </p:nvSpPr>
        <p:spPr/>
        <p:txBody>
          <a:bodyPr/>
          <a:lstStyle/>
          <a:p>
            <a:fld id="{6FF34B11-70CC-4930-9C38-3D06D92EFA49}" type="slidenum">
              <a:rPr lang="en-US" smtClean="0"/>
              <a:t>‹#›</a:t>
            </a:fld>
            <a:endParaRPr lang="en-US" dirty="0"/>
          </a:p>
        </p:txBody>
      </p:sp>
    </p:spTree>
    <p:extLst>
      <p:ext uri="{BB962C8B-B14F-4D97-AF65-F5344CB8AC3E}">
        <p14:creationId xmlns:p14="http://schemas.microsoft.com/office/powerpoint/2010/main" val="17645024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80AAE38-0F52-41C2-93B6-86FD9CB3DC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7E83F4D-D2F8-44BE-B129-7F120796EC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CA3F7B-550F-431F-98D4-69CA7179495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D64E918-A57F-47C1-81BD-0D0489642ADB}" type="datetimeFigureOut">
              <a:rPr lang="en-US" smtClean="0"/>
              <a:t>4/23/2024</a:t>
            </a:fld>
            <a:endParaRPr lang="en-US" dirty="0"/>
          </a:p>
        </p:txBody>
      </p:sp>
      <p:sp>
        <p:nvSpPr>
          <p:cNvPr id="5" name="Footer Placeholder 4">
            <a:extLst>
              <a:ext uri="{FF2B5EF4-FFF2-40B4-BE49-F238E27FC236}">
                <a16:creationId xmlns:a16="http://schemas.microsoft.com/office/drawing/2014/main" id="{FCA5D5EC-ED51-4866-AAD5-B41291E31C4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839D1BEC-BD7F-425F-BEF3-3A619AE4EC0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FF34B11-70CC-4930-9C38-3D06D92EFA49}" type="slidenum">
              <a:rPr lang="en-US" smtClean="0"/>
              <a:t>‹#›</a:t>
            </a:fld>
            <a:endParaRPr lang="en-US" dirty="0"/>
          </a:p>
        </p:txBody>
      </p:sp>
    </p:spTree>
    <p:extLst>
      <p:ext uri="{BB962C8B-B14F-4D97-AF65-F5344CB8AC3E}">
        <p14:creationId xmlns:p14="http://schemas.microsoft.com/office/powerpoint/2010/main" val="6777156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A4D62B4-2042-4DDD-9022-445AD6288793}"/>
              </a:ext>
            </a:extLst>
          </p:cNvPr>
          <p:cNvSpPr txBox="1"/>
          <p:nvPr/>
        </p:nvSpPr>
        <p:spPr>
          <a:xfrm>
            <a:off x="238237" y="339485"/>
            <a:ext cx="5044963" cy="590931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upplemental Figure 2. Additional Photomicrographs from Case 2, AT8 immunohistochemistry. (A) Low magnification (scale bar = 4 mm) image of the section in which a pathognomonic lesion for chronic traumatic encephalopathy was identified. The red box indicates the sulcal depth involved by the lesion, which is shown in more detail in Figure 2. (B) Low magnification (scale bar = 4 mm) image of an AT8-immunostained section in which the cerebral cortex and subcortical white matter are overridden with infiltrative tumor. The red box indicates a region of interest for (C) and (D). (C) and (D) High magnification (scale bars = 200 µm) images of neuronal and glial tau accumulation in cerebral cortex that is heavily infiltrated by high grade glioma; these are noted within the red box highlighted in (B). </a:t>
            </a:r>
          </a:p>
          <a:p>
            <a:r>
              <a:rPr lang="en-US" b="1" dirty="0">
                <a:latin typeface="Arial" panose="020B0604020202020204" pitchFamily="34" charset="0"/>
                <a:cs typeface="Arial" panose="020B0604020202020204" pitchFamily="34" charset="0"/>
              </a:rPr>
              <a:t> </a:t>
            </a:r>
          </a:p>
        </p:txBody>
      </p:sp>
      <p:pic>
        <p:nvPicPr>
          <p:cNvPr id="4" name="Picture 3">
            <a:extLst>
              <a:ext uri="{FF2B5EF4-FFF2-40B4-BE49-F238E27FC236}">
                <a16:creationId xmlns:a16="http://schemas.microsoft.com/office/drawing/2014/main" id="{A1E23EFF-4C27-4E8E-92C8-749947811331}"/>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25000"/>
                    </a14:imgEffect>
                  </a14:imgLayer>
                </a14:imgProps>
              </a:ext>
            </a:extLst>
          </a:blip>
          <a:stretch>
            <a:fillRect/>
          </a:stretch>
        </p:blipFill>
        <p:spPr>
          <a:xfrm>
            <a:off x="5955136" y="-117693"/>
            <a:ext cx="5540998" cy="6858000"/>
          </a:xfrm>
          <a:prstGeom prst="rect">
            <a:avLst/>
          </a:prstGeom>
        </p:spPr>
      </p:pic>
    </p:spTree>
    <p:extLst>
      <p:ext uri="{BB962C8B-B14F-4D97-AF65-F5344CB8AC3E}">
        <p14:creationId xmlns:p14="http://schemas.microsoft.com/office/powerpoint/2010/main" val="541601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TotalTime>
  <Words>159</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ymond Sobel</dc:creator>
  <cp:lastModifiedBy>Raymond Sobel</cp:lastModifiedBy>
  <cp:revision>6</cp:revision>
  <dcterms:created xsi:type="dcterms:W3CDTF">2024-04-23T20:45:36Z</dcterms:created>
  <dcterms:modified xsi:type="dcterms:W3CDTF">2024-04-23T20:58:17Z</dcterms:modified>
</cp:coreProperties>
</file>